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84"/>
    <p:restoredTop sz="96327"/>
  </p:normalViewPr>
  <p:slideViewPr>
    <p:cSldViewPr snapToGrid="0">
      <p:cViewPr>
        <p:scale>
          <a:sx n="152" d="100"/>
          <a:sy n="152" d="100"/>
        </p:scale>
        <p:origin x="2976" y="-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C7666C-4AC9-5828-B105-9BB33C9C14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4BB7DB6-D671-AA2A-10FA-CB35685B4F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9F0D50-C74A-907F-EB1B-043DCB1D2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08FEBF-E322-CA64-E4E8-54E45CDF6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E693CC-711F-ABDB-4128-FEA031409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340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DC8F39-145C-64C1-A5B6-AA2D70CF5A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CE6CD1-63F6-5086-2EB3-C9BB14D87A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E6047C-F83A-1782-13D5-06368445D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0C4D81-C583-93C0-B083-E71336F41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167B50-E77B-6AA2-D2F0-DFBF39D3C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954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C6BE27-EC3B-E3FD-4DFF-B80D6D8330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288142-13BD-7E54-E9C1-FDAA33A6FF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ABBC7B-A992-D18F-3038-86A8125CF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A89BD1-6F79-28E8-03FB-F0E94AD4F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BD91D3-92F8-4CA5-19C1-02E647F11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861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56E29-67D7-F68D-7A12-0349189B1D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2AEDB5-1368-557E-6846-3366C13227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26AB8B-7DD7-34E7-E095-E0A913099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77183B-AE6B-75FE-9675-6DA4A6902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9B402-C23B-4602-9A3C-1A65EDE3A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477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227FCD-5490-3BC3-12C4-EF883BA342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EF3F30-7E69-9C05-899F-3BD26BEB92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723D0E-A797-E1EC-DC98-854D11C61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1FB78E-6C24-D499-CA54-BD9B2D91E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E906EB-6C45-BD48-4EF6-D5C45290B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200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E6B170-9FFB-2F87-1D09-8DDDBB4C72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3FAF55-858C-68CD-C217-3385AC58FE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0A4A0E-A9AB-A369-D662-7A9E0A3148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5CDE64-ADAF-7906-C5FE-6DD1BAE2B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35C9ED-AADD-3525-976B-9BEE14ACF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5100EC-DED3-CAC2-3240-AADACDA28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361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EE66A7-A7AB-E60A-D991-B1BF0F024C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147632-6EAB-B8FF-81E9-B8085781CC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2A737A-A55C-F7C9-DFB2-4FFF955AF7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BA309C8-8410-5628-C9B3-769F4EBE29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9ED57E1-24A0-391D-3D1D-AF1A4F4001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BDF90E-5D2A-5E6B-6B8B-283903B27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081E5E-5ABF-E602-8428-92E1EB923A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DFF15E-B7BB-04E0-0232-6D51AA851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016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1B7CD7-06F2-3CC2-60E4-DF0DF3FA85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55DB20D-41F7-CAC5-882F-C7CF65D8BB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DC7E8E-B802-1681-C1D7-099333661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F1BAB5-3667-E434-9F3E-ABBB3F4D9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581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5C2A86-D891-C172-2191-F205C5E04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84C24C5-4BB6-FBF8-340F-ECCA5A9E6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4D1992-3B05-0F44-3942-01AE343EC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5973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8298B2-6F43-F875-2663-1F9A3A4AE8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F44930-5954-431A-CA66-48F21BC47E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BDC803-FBF9-90A3-884C-7DA9F25B4C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CF7D86-4A04-5C6D-A4DF-39630876A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D7D24B-4E9E-A397-4BBE-29FBB2DED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5731FE-7720-09FF-EE31-51E90D619D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8854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7EB2DE-2840-67FF-402D-CCC571AC09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5F8C673-D2AF-C03B-3C13-854044A408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C20642-F4B2-4A03-5A25-04A5B249A1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03D3E1-319B-3296-3D3C-B9C0F4542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056090-C8C0-50D2-AD9D-C456521BC0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7C7C33-2DF3-4041-3677-BE0E3268A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97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2750A00-1BD3-B56C-5185-71C594E552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90A3C-4290-A8E6-BFDE-301D7F9BC3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E1CA41-7139-2C5E-9222-9AFCCBF9C3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BFF5A-1AAE-FD4A-AE5D-43D5329CF4E8}" type="datetimeFigureOut">
              <a:rPr lang="en-US" smtClean="0"/>
              <a:t>1/7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BF312F-A724-4624-2D03-37F5103781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BABCE3-B4AC-397F-05BD-E1D2A7A736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1439BC-0874-D545-82C3-69011E6CF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330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package" Target="../embeddings/Microsoft_Word_Document.docx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AEA0D34-EF00-1E4C-9329-D09EB2994B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95647434"/>
              </p:ext>
            </p:extLst>
          </p:nvPr>
        </p:nvGraphicFramePr>
        <p:xfrm>
          <a:off x="344488" y="315913"/>
          <a:ext cx="6794500" cy="551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6794500" imgH="5511800" progId="Word.Document.12">
                  <p:embed/>
                </p:oleObj>
              </mc:Choice>
              <mc:Fallback>
                <p:oleObj name="Document" r:id="rId2" imgW="6794500" imgH="5511800" progId="Word.Document.12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130BE044-F1A3-6C9C-2AF1-38ED5736DD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4488" y="315913"/>
                        <a:ext cx="6794500" cy="551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79281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A9AB91A-6CA2-D554-90AB-A0DC3C35B4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4023008"/>
              </p:ext>
            </p:extLst>
          </p:nvPr>
        </p:nvGraphicFramePr>
        <p:xfrm>
          <a:off x="925893" y="1057834"/>
          <a:ext cx="4518562" cy="5467174"/>
        </p:xfrm>
        <a:graphic>
          <a:graphicData uri="http://schemas.openxmlformats.org/drawingml/2006/table">
            <a:tbl>
              <a:tblPr/>
              <a:tblGrid>
                <a:gridCol w="2259281">
                  <a:extLst>
                    <a:ext uri="{9D8B030D-6E8A-4147-A177-3AD203B41FA5}">
                      <a16:colId xmlns:a16="http://schemas.microsoft.com/office/drawing/2014/main" val="37128430"/>
                    </a:ext>
                  </a:extLst>
                </a:gridCol>
                <a:gridCol w="2259281">
                  <a:extLst>
                    <a:ext uri="{9D8B030D-6E8A-4147-A177-3AD203B41FA5}">
                      <a16:colId xmlns:a16="http://schemas.microsoft.com/office/drawing/2014/main" val="2166952140"/>
                    </a:ext>
                  </a:extLst>
                </a:gridCol>
              </a:tblGrid>
              <a:tr h="464999">
                <a:tc gridSpan="2">
                  <a:txBody>
                    <a:bodyPr/>
                    <a:lstStyle/>
                    <a:p>
                      <a:pPr algn="l" fontAlgn="t"/>
                      <a:r>
                        <a:rPr lang="en-US" sz="1600" dirty="0">
                          <a:effectLst/>
                        </a:rPr>
                        <a:t>Representativeness of Study Participants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5F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1024848"/>
                  </a:ext>
                </a:extLst>
              </a:tr>
              <a:tr h="501983"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 dirty="0">
                          <a:effectLst/>
                        </a:rPr>
                        <a:t>Cancer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 dirty="0">
                          <a:effectLst/>
                        </a:rPr>
                        <a:t>Prostate Cancer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188874"/>
                  </a:ext>
                </a:extLst>
              </a:tr>
              <a:tr h="260050">
                <a:tc gridSpan="2">
                  <a:txBody>
                    <a:bodyPr/>
                    <a:lstStyle/>
                    <a:p>
                      <a:pPr algn="l" fontAlgn="t"/>
                      <a:r>
                        <a:rPr lang="en-US" sz="1600">
                          <a:effectLst/>
                        </a:rPr>
                        <a:t>Considerations related to: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5F5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5329094"/>
                  </a:ext>
                </a:extLst>
              </a:tr>
              <a:tr h="464999"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>
                          <a:effectLst/>
                        </a:rPr>
                        <a:t>Sex</a:t>
                      </a:r>
                    </a:p>
                  </a:txBody>
                  <a:tcPr marL="36876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 dirty="0">
                          <a:effectLst/>
                        </a:rPr>
                        <a:t>Prostate cancer occurs in men.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7451351"/>
                  </a:ext>
                </a:extLst>
              </a:tr>
              <a:tr h="669948"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>
                          <a:effectLst/>
                        </a:rPr>
                        <a:t>Age</a:t>
                      </a:r>
                    </a:p>
                  </a:txBody>
                  <a:tcPr marL="36876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 dirty="0">
                          <a:effectLst/>
                        </a:rPr>
                        <a:t>The median age at the time of all prostate cancer diagnoses is around 67.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0644193"/>
                  </a:ext>
                </a:extLst>
              </a:tr>
              <a:tr h="1079845"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>
                          <a:effectLst/>
                        </a:rPr>
                        <a:t>Race/ethnicity</a:t>
                      </a:r>
                    </a:p>
                  </a:txBody>
                  <a:tcPr marL="36876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 dirty="0">
                          <a:effectLst/>
                        </a:rPr>
                        <a:t>Of men diagnosed with prostate cancer in the United States, 70% are Caucasian, 12% are Black and 10% are Hispanic.  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7903938"/>
                  </a:ext>
                </a:extLst>
              </a:tr>
              <a:tr h="338798"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>
                          <a:effectLst/>
                        </a:rPr>
                        <a:t>Geography</a:t>
                      </a:r>
                    </a:p>
                  </a:txBody>
                  <a:tcPr marL="36876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 dirty="0">
                          <a:effectLst/>
                        </a:rPr>
                        <a:t>Not applicable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3324431"/>
                  </a:ext>
                </a:extLst>
              </a:tr>
              <a:tr h="1380818"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>
                          <a:effectLst/>
                        </a:rPr>
                        <a:t>Overall representativeness of this study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600" dirty="0">
                          <a:effectLst/>
                        </a:rPr>
                        <a:t>The mean age in our study was 65 years.  The racial distribution in our study is representative of a national cohort.</a:t>
                      </a:r>
                    </a:p>
                  </a:txBody>
                  <a:tcPr marL="12292" marR="12292" marT="12292" marB="12292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solidFill>
                        <a:srgbClr val="8010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400E3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091152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DD50454C-17A0-F03B-54E2-D921103A2DEF}"/>
              </a:ext>
            </a:extLst>
          </p:cNvPr>
          <p:cNvSpPr txBox="1"/>
          <p:nvPr/>
        </p:nvSpPr>
        <p:spPr>
          <a:xfrm>
            <a:off x="817926" y="452897"/>
            <a:ext cx="609879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effectLst/>
              </a:rPr>
              <a:t>Supplementary Table 2 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190005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97</Words>
  <Application>Microsoft Macintosh PowerPoint</Application>
  <PresentationFormat>Widescreen</PresentationFormat>
  <Paragraphs>15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Document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Hyung</dc:creator>
  <cp:lastModifiedBy>Kim, Hyung</cp:lastModifiedBy>
  <cp:revision>2</cp:revision>
  <dcterms:created xsi:type="dcterms:W3CDTF">2023-09-08T04:10:39Z</dcterms:created>
  <dcterms:modified xsi:type="dcterms:W3CDTF">2024-01-07T15:02:33Z</dcterms:modified>
</cp:coreProperties>
</file>